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78" y="3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7EADD6-5DCB-4F7D-96DD-3E947717939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BEA543-C530-4CA0-B10D-E2ED0D11B418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57368" y="180943"/>
            <a:ext cx="3736662" cy="5120265"/>
            <a:chOff x="257368" y="180943"/>
            <a:chExt cx="3736662" cy="512026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r="16548"/>
            <a:stretch>
              <a:fillRect/>
            </a:stretch>
          </p:blipFill>
          <p:spPr bwMode="auto">
            <a:xfrm>
              <a:off x="257368" y="180943"/>
              <a:ext cx="3450536" cy="4339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498920" y="4470211"/>
              <a:ext cx="349511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800" b="1" dirty="0" smtClean="0"/>
                <a:t>Additional file 4</a:t>
              </a:r>
              <a:r>
                <a:rPr lang="en-NZ" sz="800" dirty="0" smtClean="0"/>
                <a:t>:</a:t>
              </a:r>
              <a:r>
                <a:rPr lang="en-NZ" sz="800" b="1" dirty="0" smtClean="0"/>
                <a:t> </a:t>
              </a:r>
              <a:r>
                <a:rPr lang="en-NZ" sz="800" dirty="0" smtClean="0"/>
                <a:t>The core- and pan- genome of 14 </a:t>
              </a:r>
              <a:r>
                <a:rPr lang="en-NZ" sz="800" i="1" dirty="0" smtClean="0"/>
                <a:t>Arthrobacter</a:t>
              </a:r>
              <a:r>
                <a:rPr lang="en-NZ" sz="800" dirty="0" smtClean="0"/>
                <a:t> genomes calculated using BLAST in CMG </a:t>
              </a:r>
              <a:r>
                <a:rPr lang="en-NZ" sz="800" dirty="0" err="1" smtClean="0"/>
                <a:t>Biotools</a:t>
              </a:r>
              <a:r>
                <a:rPr lang="en-NZ" sz="800" dirty="0" smtClean="0"/>
                <a:t>. 1, </a:t>
              </a:r>
              <a:r>
                <a:rPr lang="en-NZ" sz="800" i="1" dirty="0" smtClean="0"/>
                <a:t>A</a:t>
              </a:r>
              <a:r>
                <a:rPr lang="en-NZ" sz="800" dirty="0" smtClean="0"/>
                <a:t>. </a:t>
              </a:r>
              <a:r>
                <a:rPr lang="en-NZ" sz="800" i="1" dirty="0" err="1" smtClean="0"/>
                <a:t>aurescens</a:t>
              </a:r>
              <a:r>
                <a:rPr lang="en-NZ" sz="800" i="1" dirty="0" smtClean="0"/>
                <a:t> </a:t>
              </a:r>
              <a:r>
                <a:rPr lang="en-NZ" sz="800" dirty="0" smtClean="0"/>
                <a:t>TC1; 2, </a:t>
              </a:r>
              <a:r>
                <a:rPr lang="en-NZ" sz="800" i="1" dirty="0" smtClean="0"/>
                <a:t>A</a:t>
              </a:r>
              <a:r>
                <a:rPr lang="en-NZ" sz="800" dirty="0" smtClean="0"/>
                <a:t>. </a:t>
              </a:r>
              <a:r>
                <a:rPr lang="en-NZ" sz="800" i="1" dirty="0" err="1" smtClean="0"/>
                <a:t>castelli</a:t>
              </a:r>
              <a:r>
                <a:rPr lang="en-NZ" sz="800" i="1" dirty="0" smtClean="0"/>
                <a:t> </a:t>
              </a:r>
              <a:r>
                <a:rPr lang="en-NZ" sz="800" dirty="0" smtClean="0"/>
                <a:t>DSM 16402; 3, </a:t>
              </a:r>
              <a:r>
                <a:rPr lang="en-NZ" sz="800" i="1" dirty="0" smtClean="0"/>
                <a:t>A</a:t>
              </a:r>
              <a:r>
                <a:rPr lang="en-NZ" sz="800" dirty="0" smtClean="0"/>
                <a:t>.</a:t>
              </a:r>
              <a:r>
                <a:rPr lang="en-NZ" sz="800" i="1" dirty="0" smtClean="0"/>
                <a:t> chlorophenolicus </a:t>
              </a:r>
              <a:r>
                <a:rPr lang="en-NZ" sz="800" dirty="0" smtClean="0"/>
                <a:t>A6; 4, </a:t>
              </a:r>
              <a:r>
                <a:rPr lang="en-NZ" sz="800" i="1" dirty="0" smtClean="0"/>
                <a:t>Arthrobacter </a:t>
              </a:r>
              <a:r>
                <a:rPr lang="en-NZ" sz="800" dirty="0" smtClean="0"/>
                <a:t>sp. FB24; 5, </a:t>
              </a:r>
              <a:r>
                <a:rPr lang="en-NZ" sz="800" i="1" dirty="0" smtClean="0"/>
                <a:t>A</a:t>
              </a:r>
              <a:r>
                <a:rPr lang="en-NZ" sz="800" dirty="0" smtClean="0"/>
                <a:t>. </a:t>
              </a:r>
              <a:r>
                <a:rPr lang="en-NZ" sz="800" i="1" dirty="0" err="1" smtClean="0"/>
                <a:t>globiformis</a:t>
              </a:r>
              <a:r>
                <a:rPr lang="en-NZ" sz="800" i="1" dirty="0" smtClean="0"/>
                <a:t> </a:t>
              </a:r>
              <a:r>
                <a:rPr lang="en-NZ" sz="800" dirty="0" smtClean="0"/>
                <a:t>NBRC  12137; 6, </a:t>
              </a:r>
              <a:r>
                <a:rPr lang="en-NZ" sz="800" i="1" dirty="0" smtClean="0"/>
                <a:t>A</a:t>
              </a:r>
              <a:r>
                <a:rPr lang="en-NZ" sz="800" dirty="0" smtClean="0"/>
                <a:t>. </a:t>
              </a:r>
              <a:r>
                <a:rPr lang="en-NZ" sz="800" i="1" dirty="0" err="1" smtClean="0"/>
                <a:t>nitroguajacolicus</a:t>
              </a:r>
              <a:r>
                <a:rPr lang="en-NZ" sz="800" i="1" dirty="0" smtClean="0"/>
                <a:t> </a:t>
              </a:r>
              <a:r>
                <a:rPr lang="en-NZ" sz="800" dirty="0" smtClean="0"/>
                <a:t> Rue61a; 7, </a:t>
              </a:r>
              <a:r>
                <a:rPr lang="en-NZ" sz="800" i="1" dirty="0" smtClean="0"/>
                <a:t>A</a:t>
              </a:r>
              <a:r>
                <a:rPr lang="en-NZ" sz="800" dirty="0" smtClean="0"/>
                <a:t>. </a:t>
              </a:r>
              <a:r>
                <a:rPr lang="en-NZ" sz="800" i="1" dirty="0" err="1" smtClean="0"/>
                <a:t>phenanthrenivorans</a:t>
              </a:r>
              <a:r>
                <a:rPr lang="en-NZ" sz="800" i="1" dirty="0" smtClean="0"/>
                <a:t> </a:t>
              </a:r>
              <a:r>
                <a:rPr lang="en-NZ" sz="800" dirty="0" smtClean="0"/>
                <a:t>Sphe3; 8, Br18; 9, H14; 10, H20; 11, H41; 12, H5; 13, I3; 14, 35/47. </a:t>
              </a:r>
              <a:endParaRPr lang="en-US" sz="800" b="1" dirty="0" smtClean="0"/>
            </a:p>
            <a:p>
              <a:endParaRPr lang="en-NZ" sz="8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o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dso006</dc:creator>
  <cp:lastModifiedBy>mdso006</cp:lastModifiedBy>
  <cp:revision>5</cp:revision>
  <dcterms:created xsi:type="dcterms:W3CDTF">2013-11-20T20:48:22Z</dcterms:created>
  <dcterms:modified xsi:type="dcterms:W3CDTF">2014-06-01T07:50:43Z</dcterms:modified>
</cp:coreProperties>
</file>